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2D5C7A-BE05-4727-815A-B088AD0C650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B8680C-3547-4EB9-BDB3-CD47C0621DB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1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AE707-FCCA-4B78-BE61-B3E5D15A30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018B4-6ACF-4B89-AAFF-769016FD42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D59763-E3D2-4A43-9C61-D744F9B47E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CEA45-4316-4E4C-B7EA-FF39A73C35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84DDF-E162-4E8D-A5F6-4BFC2B84E3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BA4CC-817B-4EB2-9FEF-5B732CDA5A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94CE6-1C7F-43F4-B421-7C9AAE238D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FE7624-A61C-4806-9445-BFB8FF7EF9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314B0-E111-461D-ACBD-19BBA90840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C98DD-61C1-4F14-A615-8DA48D5EB5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ADCB0F-722F-41F1-B116-50205C9230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058A8-29DE-44FF-9C1C-78A72EF7AD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701319-2883-48E8-AFAF-E2D5ADAB94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1174680" y="5792760"/>
            <a:ext cx="5257800" cy="533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9" name="Line 5"/>
          <p:cNvSpPr/>
          <p:nvPr/>
        </p:nvSpPr>
        <p:spPr>
          <a:xfrm flipH="1">
            <a:off x="4222800" y="7062840"/>
            <a:ext cx="144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6"/>
          <p:cNvSpPr/>
          <p:nvPr/>
        </p:nvSpPr>
        <p:spPr>
          <a:xfrm flipH="1">
            <a:off x="2698560" y="7062840"/>
            <a:ext cx="1447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7"/>
          <p:cNvSpPr/>
          <p:nvPr/>
        </p:nvSpPr>
        <p:spPr>
          <a:xfrm flipH="1">
            <a:off x="1174680" y="7062840"/>
            <a:ext cx="144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8"/>
          <p:cNvSpPr/>
          <p:nvPr/>
        </p:nvSpPr>
        <p:spPr>
          <a:xfrm>
            <a:off x="5746680" y="7062840"/>
            <a:ext cx="685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10" descr=""/>
          <p:cNvPicPr/>
          <p:nvPr/>
        </p:nvPicPr>
        <p:blipFill>
          <a:blip r:embed="rId2"/>
          <a:stretch/>
        </p:blipFill>
        <p:spPr>
          <a:xfrm>
            <a:off x="1174680" y="6465960"/>
            <a:ext cx="5257800" cy="484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4" name="Text Box 19"/>
          <p:cNvSpPr/>
          <p:nvPr/>
        </p:nvSpPr>
        <p:spPr>
          <a:xfrm rot="18740400">
            <a:off x="6049800" y="5345640"/>
            <a:ext cx="73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GF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36"/>
          <p:cNvSpPr/>
          <p:nvPr/>
        </p:nvSpPr>
        <p:spPr>
          <a:xfrm>
            <a:off x="1555920" y="7031160"/>
            <a:ext cx="8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T-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37"/>
          <p:cNvSpPr/>
          <p:nvPr/>
        </p:nvSpPr>
        <p:spPr>
          <a:xfrm>
            <a:off x="3079800" y="7031160"/>
            <a:ext cx="8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T-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38"/>
          <p:cNvSpPr/>
          <p:nvPr/>
        </p:nvSpPr>
        <p:spPr>
          <a:xfrm>
            <a:off x="4603680" y="7031160"/>
            <a:ext cx="838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T- 1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43"/>
          <p:cNvSpPr/>
          <p:nvPr/>
        </p:nvSpPr>
        <p:spPr>
          <a:xfrm>
            <a:off x="5746680" y="7031160"/>
            <a:ext cx="838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T-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47"/>
          <p:cNvSpPr/>
          <p:nvPr/>
        </p:nvSpPr>
        <p:spPr>
          <a:xfrm>
            <a:off x="946080" y="6757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48"/>
          <p:cNvSpPr/>
          <p:nvPr/>
        </p:nvSpPr>
        <p:spPr>
          <a:xfrm>
            <a:off x="946080" y="6118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49"/>
          <p:cNvSpPr/>
          <p:nvPr/>
        </p:nvSpPr>
        <p:spPr>
          <a:xfrm>
            <a:off x="946080" y="60087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51"/>
          <p:cNvSpPr/>
          <p:nvPr/>
        </p:nvSpPr>
        <p:spPr>
          <a:xfrm>
            <a:off x="31680" y="6605640"/>
            <a:ext cx="106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4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-Tubuli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54"/>
          <p:cNvSpPr/>
          <p:nvPr/>
        </p:nvSpPr>
        <p:spPr>
          <a:xfrm>
            <a:off x="31680" y="5856120"/>
            <a:ext cx="13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-M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55"/>
          <p:cNvSpPr/>
          <p:nvPr/>
        </p:nvSpPr>
        <p:spPr>
          <a:xfrm>
            <a:off x="31680" y="6008760"/>
            <a:ext cx="13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-M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6"/>
          <p:cNvSpPr/>
          <p:nvPr/>
        </p:nvSpPr>
        <p:spPr>
          <a:xfrm>
            <a:off x="3164040" y="7881840"/>
            <a:ext cx="1904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 / </a:t>
            </a:r>
            <a:r>
              <a:rPr b="1" lang="el-GR" sz="14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57"/>
          <p:cNvSpPr/>
          <p:nvPr/>
        </p:nvSpPr>
        <p:spPr>
          <a:xfrm>
            <a:off x="119160" y="7348680"/>
            <a:ext cx="640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-M1:        0.6           0.6           0.4          0.4          0.3         0.3            0.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58"/>
          <p:cNvSpPr/>
          <p:nvPr/>
        </p:nvSpPr>
        <p:spPr>
          <a:xfrm>
            <a:off x="119160" y="7535880"/>
            <a:ext cx="640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-M2:        0.4           0.4           0.3          0.4          0.3         0.2            0.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6"/>
          <p:cNvSpPr/>
          <p:nvPr/>
        </p:nvSpPr>
        <p:spPr>
          <a:xfrm>
            <a:off x="1371600" y="649440"/>
            <a:ext cx="457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Group 76"/>
          <p:cNvGrpSpPr/>
          <p:nvPr/>
        </p:nvGrpSpPr>
        <p:grpSpPr>
          <a:xfrm>
            <a:off x="1200240" y="4684680"/>
            <a:ext cx="5603760" cy="1189800"/>
            <a:chOff x="1200240" y="4684680"/>
            <a:chExt cx="5603760" cy="1189800"/>
          </a:xfrm>
        </p:grpSpPr>
        <p:sp>
          <p:nvSpPr>
            <p:cNvPr id="70" name="Text Box 12"/>
            <p:cNvSpPr/>
            <p:nvPr/>
          </p:nvSpPr>
          <p:spPr>
            <a:xfrm rot="18740400">
              <a:off x="1101960" y="5138280"/>
              <a:ext cx="129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melanom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16"/>
            <p:cNvSpPr/>
            <p:nvPr/>
          </p:nvSpPr>
          <p:spPr>
            <a:xfrm rot="18740400">
              <a:off x="1920600" y="5138280"/>
              <a:ext cx="129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djac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17"/>
            <p:cNvSpPr/>
            <p:nvPr/>
          </p:nvSpPr>
          <p:spPr>
            <a:xfrm rot="18740400">
              <a:off x="3460680" y="5138280"/>
              <a:ext cx="129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djac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18"/>
            <p:cNvSpPr/>
            <p:nvPr/>
          </p:nvSpPr>
          <p:spPr>
            <a:xfrm rot="18740400">
              <a:off x="5007600" y="5138280"/>
              <a:ext cx="129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djac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20"/>
            <p:cNvSpPr/>
            <p:nvPr/>
          </p:nvSpPr>
          <p:spPr>
            <a:xfrm rot="18740400">
              <a:off x="5605920" y="5138280"/>
              <a:ext cx="129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djac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12"/>
            <p:cNvSpPr/>
            <p:nvPr/>
          </p:nvSpPr>
          <p:spPr>
            <a:xfrm rot="18740400">
              <a:off x="2706840" y="5113440"/>
              <a:ext cx="129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melanom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12"/>
            <p:cNvSpPr/>
            <p:nvPr/>
          </p:nvSpPr>
          <p:spPr>
            <a:xfrm rot="18740400">
              <a:off x="4314960" y="5135040"/>
              <a:ext cx="129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melanom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7" name="Text Box 39"/>
          <p:cNvSpPr/>
          <p:nvPr/>
        </p:nvSpPr>
        <p:spPr>
          <a:xfrm>
            <a:off x="0" y="15228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30"/>
          <p:cNvSpPr/>
          <p:nvPr/>
        </p:nvSpPr>
        <p:spPr>
          <a:xfrm rot="18740400">
            <a:off x="6189120" y="388800"/>
            <a:ext cx="89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GF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+ x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75"/>
          <p:cNvSpPr/>
          <p:nvPr/>
        </p:nvSpPr>
        <p:spPr>
          <a:xfrm>
            <a:off x="2936880" y="4648320"/>
            <a:ext cx="2286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GF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+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x [</a:t>
            </a: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m1m2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]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+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76"/>
          <p:cNvSpPr/>
          <p:nvPr/>
        </p:nvSpPr>
        <p:spPr>
          <a:xfrm>
            <a:off x="1260360" y="4935600"/>
            <a:ext cx="4572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77"/>
          <p:cNvSpPr/>
          <p:nvPr/>
        </p:nvSpPr>
        <p:spPr>
          <a:xfrm>
            <a:off x="76320" y="4495680"/>
            <a:ext cx="609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79"/>
          <p:cNvSpPr/>
          <p:nvPr/>
        </p:nvSpPr>
        <p:spPr>
          <a:xfrm>
            <a:off x="4572000" y="8655120"/>
            <a:ext cx="2590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9" descr=""/>
          <p:cNvPicPr/>
          <p:nvPr/>
        </p:nvPicPr>
        <p:blipFill>
          <a:blip r:embed="rId3"/>
          <a:stretch/>
        </p:blipFill>
        <p:spPr>
          <a:xfrm>
            <a:off x="1143000" y="2147760"/>
            <a:ext cx="5257800" cy="481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4" name="Picture 11" descr=""/>
          <p:cNvPicPr/>
          <p:nvPr/>
        </p:nvPicPr>
        <p:blipFill>
          <a:blip r:embed="rId4"/>
          <a:stretch/>
        </p:blipFill>
        <p:spPr>
          <a:xfrm>
            <a:off x="1143000" y="1538280"/>
            <a:ext cx="5257800" cy="495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5" name="Text Box 21"/>
          <p:cNvSpPr/>
          <p:nvPr/>
        </p:nvSpPr>
        <p:spPr>
          <a:xfrm rot="18740400">
            <a:off x="1105560" y="902520"/>
            <a:ext cx="1295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elanom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23"/>
          <p:cNvSpPr/>
          <p:nvPr/>
        </p:nvSpPr>
        <p:spPr>
          <a:xfrm rot="18740400">
            <a:off x="4155120" y="890280"/>
            <a:ext cx="129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elanom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25"/>
          <p:cNvSpPr/>
          <p:nvPr/>
        </p:nvSpPr>
        <p:spPr>
          <a:xfrm rot="18740400">
            <a:off x="2629440" y="890280"/>
            <a:ext cx="129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elanom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27"/>
          <p:cNvSpPr/>
          <p:nvPr/>
        </p:nvSpPr>
        <p:spPr>
          <a:xfrm rot="18740400">
            <a:off x="1809000" y="902520"/>
            <a:ext cx="1295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djac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28"/>
          <p:cNvSpPr/>
          <p:nvPr/>
        </p:nvSpPr>
        <p:spPr>
          <a:xfrm rot="18740400">
            <a:off x="3412080" y="902520"/>
            <a:ext cx="1295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djac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29"/>
          <p:cNvSpPr/>
          <p:nvPr/>
        </p:nvSpPr>
        <p:spPr>
          <a:xfrm rot="18740400">
            <a:off x="4877640" y="902520"/>
            <a:ext cx="1295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djac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1"/>
          <p:cNvSpPr/>
          <p:nvPr/>
        </p:nvSpPr>
        <p:spPr>
          <a:xfrm rot="18740400">
            <a:off x="5615280" y="980280"/>
            <a:ext cx="960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djac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32"/>
          <p:cNvSpPr/>
          <p:nvPr/>
        </p:nvSpPr>
        <p:spPr>
          <a:xfrm flipH="1">
            <a:off x="4190760" y="2757600"/>
            <a:ext cx="1447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33"/>
          <p:cNvSpPr/>
          <p:nvPr/>
        </p:nvSpPr>
        <p:spPr>
          <a:xfrm flipH="1">
            <a:off x="2666880" y="2757600"/>
            <a:ext cx="144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34"/>
          <p:cNvSpPr/>
          <p:nvPr/>
        </p:nvSpPr>
        <p:spPr>
          <a:xfrm flipH="1">
            <a:off x="1143000" y="2757600"/>
            <a:ext cx="1447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35"/>
          <p:cNvSpPr/>
          <p:nvPr/>
        </p:nvSpPr>
        <p:spPr>
          <a:xfrm>
            <a:off x="5715000" y="2757600"/>
            <a:ext cx="685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39"/>
          <p:cNvSpPr/>
          <p:nvPr/>
        </p:nvSpPr>
        <p:spPr>
          <a:xfrm>
            <a:off x="1447920" y="2725560"/>
            <a:ext cx="8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T-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40"/>
          <p:cNvSpPr/>
          <p:nvPr/>
        </p:nvSpPr>
        <p:spPr>
          <a:xfrm>
            <a:off x="3048120" y="2725560"/>
            <a:ext cx="8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T-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41"/>
          <p:cNvSpPr/>
          <p:nvPr/>
        </p:nvSpPr>
        <p:spPr>
          <a:xfrm>
            <a:off x="4572000" y="2725560"/>
            <a:ext cx="8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T- 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42"/>
          <p:cNvSpPr/>
          <p:nvPr/>
        </p:nvSpPr>
        <p:spPr>
          <a:xfrm>
            <a:off x="5715000" y="2725560"/>
            <a:ext cx="83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T-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44"/>
          <p:cNvSpPr/>
          <p:nvPr/>
        </p:nvSpPr>
        <p:spPr>
          <a:xfrm>
            <a:off x="914400" y="24526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45"/>
          <p:cNvSpPr/>
          <p:nvPr/>
        </p:nvSpPr>
        <p:spPr>
          <a:xfrm>
            <a:off x="914400" y="1843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46"/>
          <p:cNvSpPr/>
          <p:nvPr/>
        </p:nvSpPr>
        <p:spPr>
          <a:xfrm>
            <a:off x="914400" y="17668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50"/>
          <p:cNvSpPr/>
          <p:nvPr/>
        </p:nvSpPr>
        <p:spPr>
          <a:xfrm>
            <a:off x="0" y="230040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4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Times New Roman"/>
              </a:rPr>
              <a:t>-Tubuli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52"/>
          <p:cNvSpPr/>
          <p:nvPr/>
        </p:nvSpPr>
        <p:spPr>
          <a:xfrm>
            <a:off x="0" y="1614600"/>
            <a:ext cx="13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-M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53"/>
          <p:cNvSpPr/>
          <p:nvPr/>
        </p:nvSpPr>
        <p:spPr>
          <a:xfrm>
            <a:off x="0" y="1766880"/>
            <a:ext cx="137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-M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61"/>
          <p:cNvSpPr/>
          <p:nvPr/>
        </p:nvSpPr>
        <p:spPr>
          <a:xfrm>
            <a:off x="76320" y="3062160"/>
            <a:ext cx="6400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-M1:        1.5          1.4          1.4           1.4            0.9            1             0.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62"/>
          <p:cNvSpPr/>
          <p:nvPr/>
        </p:nvSpPr>
        <p:spPr>
          <a:xfrm>
            <a:off x="76320" y="3290760"/>
            <a:ext cx="6400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-M2:        1.1          0.8          1.1           0.9            0.6          0.7            0.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78"/>
          <p:cNvSpPr/>
          <p:nvPr/>
        </p:nvSpPr>
        <p:spPr>
          <a:xfrm rot="18576600">
            <a:off x="5906160" y="966240"/>
            <a:ext cx="99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Arial"/>
              </a:rPr>
              <a:t>[m1m2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]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+/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56"/>
          <p:cNvSpPr/>
          <p:nvPr/>
        </p:nvSpPr>
        <p:spPr>
          <a:xfrm>
            <a:off x="3048120" y="3689280"/>
            <a:ext cx="1904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M23 / </a:t>
            </a:r>
            <a:r>
              <a:rPr b="1" lang="el-GR" sz="14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38"/>
          <p:cNvSpPr/>
          <p:nvPr/>
        </p:nvSpPr>
        <p:spPr>
          <a:xfrm>
            <a:off x="3297240" y="363600"/>
            <a:ext cx="76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GF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14T15:10:53Z</dcterms:created>
  <dc:creator>UKHC ITS</dc:creator>
  <dc:description/>
  <dc:language>en-US</dc:language>
  <cp:lastModifiedBy>dmkaetz</cp:lastModifiedBy>
  <dcterms:modified xsi:type="dcterms:W3CDTF">2012-05-14T18:22:03Z</dcterms:modified>
  <cp:revision>5</cp:revision>
  <dc:subject/>
  <dc:title>Slide 1</dc:title>
</cp:coreProperties>
</file>